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1700" r:id="rId2"/>
    <p:sldId id="169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/>
    <p:restoredTop sz="80631"/>
  </p:normalViewPr>
  <p:slideViewPr>
    <p:cSldViewPr snapToGrid="0">
      <p:cViewPr varScale="1">
        <p:scale>
          <a:sx n="87" d="100"/>
          <a:sy n="87" d="100"/>
        </p:scale>
        <p:origin x="3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811E5C-81DF-9B43-BF14-B7CEB094E119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F9DD1D-A0C3-6B4A-8C4D-C63F34377F0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48632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BF1DDA-BEF5-6D4A-96BA-90D248CE338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37740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BF1DDA-BEF5-6D4A-96BA-90D248CE3388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0174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BB8186-A1CF-A70D-331F-384670552C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EAE9644-CC20-F99B-969D-DBA0E78196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981A9AC-D4A5-2FA5-123D-F7495DC91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C319F3-3049-CFE7-8FEE-395BFA9C2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0CAE447-6155-785B-84C1-7D1FE5462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8334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39675C-9328-FD22-84BD-16C3FDAE3A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26D2A78-50DD-D238-18FD-9A46A4E00A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54FB2C7-70BC-5D4A-FF4C-B3E578840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61E34B-A4FB-D665-5FD0-FD13B52E7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A77C224-E467-C694-13E9-424F57DF5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4914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E114A6D-3140-7F32-1C1B-EE5776F655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E8766F9-D839-A80B-968D-EF76638381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65F3F9D-E941-F425-27E6-849E0A4D4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7ED871C-1032-D136-29CA-6ABD53A01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CE33BA-8F2F-9CF7-9487-6FE4E1971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8626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6AC0FA-060A-A916-9C97-E3763AAD2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02BB479-22A7-F636-E675-8E68E3E180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563BE10-F388-E7D4-9902-54A7BDA01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F13CC8B-E914-4ABE-BCB5-F2CC39644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AC0A5A8-6A52-F3FF-4176-08649860B3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9719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1D55C0F-8DEC-1830-8D59-5F0CA73960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2A6B91C-F342-5A38-3118-160C35E92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11E870-863F-D921-9AC5-0E00FE916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9EA854-CFAF-3F7C-8B85-727678C03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A23A5CB-AAF0-7208-BC03-D50C56CAB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073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AAE769-18DA-C08B-24C3-B1BA1F5ABE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FA01AAA-5805-F7F4-50B1-D1AC59569E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B6F9A1D-F007-4106-C87D-BD4EDF40D3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D19DAC7-F3E1-1FB8-D90A-A3850BA33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A0E33C5-1B47-6138-7774-9539F856A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AFB3B5B-386F-D5A0-B6BD-9518A7F12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574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37AE46-B7D0-1E53-3A3D-A33F22FC4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9BB93F4-2E61-FFC9-987F-CA9A7BC803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F08273D-36BE-A91E-ACC2-2507ED3C92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8E3C7CD-F345-7BF2-0449-4E10CF54A9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A4340C3-C87C-0AF6-4D0D-406A966D5C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5E6D478-46F1-16DA-E62E-0DD0A745B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65B7F35-EC22-F686-12BE-DF5CED38F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E743E16-CA5B-2FC5-3AB0-87E349F71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9643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A93B74-68A5-7528-27A0-57F6CB32B8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00C5C00-B241-2BFE-C7B1-00DB49022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A3E25C9-57C6-0186-CC10-351FA8319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DE40444F-8472-7129-1ED4-2D48BF723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4317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C2CE0BC-9A1D-D5DE-7B0A-F803F195F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1CB1CD-3A36-B7F4-937E-3ECB77F90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E21F66D-C10E-6CD8-50DC-F89D36C0E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2067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29B726-3660-FE05-1108-4B23FF1965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3F0FD18-E863-BE3D-897F-D017291BD6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4B7C6A7-D421-ED4A-A688-AB66CC7215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1B0CD90-B720-A83C-AD13-FC3EDE3C0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6AE64F6-AD4E-7624-13BB-2EA418DD8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31BE9EF-250C-1C0C-D5DA-769CD57DD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834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AC12D1-A298-80D7-BE98-12ABCBB929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A854AA8-91E6-CC24-130F-5D8F39100D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DF4F017-5ED9-2023-BD60-B448D81215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1087B1C-BA99-F0D3-3220-A1F206A71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52A8D10-9B76-A899-DB07-E2207C197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A547E93-80E3-FB74-84E9-44DA8BF68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4059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B4CEAB1-16B3-F6DF-A167-F5D78EE45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480C91F-27C6-FD9F-20A8-1A54B39AF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D964CA8-1884-CE28-1AB0-C0DC953E5C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F1EEF-4EC7-8543-8232-A2278C4997B8}" type="datetimeFigureOut">
              <a:rPr lang="de-DE" smtClean="0"/>
              <a:t>03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2D2112-115E-625C-2020-9DC86A7C5D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C7EED3-8191-A8C5-BD97-B3063B5774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945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779764F-D887-BB44-BAC8-3FFF02080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593BD-2FAD-9843-96E5-C3CD8F1015F4}" type="slidenum">
              <a:rPr lang="de-DE" smtClean="0"/>
              <a:t>1</a:t>
            </a:fld>
            <a:endParaRPr lang="de-DE"/>
          </a:p>
        </p:txBody>
      </p:sp>
      <p:pic>
        <p:nvPicPr>
          <p:cNvPr id="6" name="Inhaltsplatzhalter 5">
            <a:extLst>
              <a:ext uri="{FF2B5EF4-FFF2-40B4-BE49-F238E27FC236}">
                <a16:creationId xmlns:a16="http://schemas.microsoft.com/office/drawing/2014/main" id="{96AEACC2-35A4-0646-8C53-AB7E6FDDE32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-36068" t="-38595" r="-21968" b="-75822"/>
          <a:stretch/>
        </p:blipFill>
        <p:spPr>
          <a:xfrm>
            <a:off x="-909024" y="4494063"/>
            <a:ext cx="5790213" cy="1611491"/>
          </a:xfr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00284C58-78B8-AA49-BC20-DB7E4F0D34B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2" t="-182" r="398" b="-27287"/>
          <a:stretch/>
        </p:blipFill>
        <p:spPr>
          <a:xfrm>
            <a:off x="377207" y="1580389"/>
            <a:ext cx="3608270" cy="3697221"/>
          </a:xfrm>
          <a:prstGeom prst="rect">
            <a:avLst/>
          </a:prstGeom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E62B175E-F7C1-8C5F-37B3-47C424B635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rmAutofit/>
          </a:bodyPr>
          <a:lstStyle/>
          <a:p>
            <a:r>
              <a:rPr lang="de-DE" sz="2400">
                <a:latin typeface="Arial" panose="020B0604020202020204" pitchFamily="34" charset="0"/>
                <a:cs typeface="Arial" panose="020B0604020202020204" pitchFamily="34" charset="0"/>
              </a:rPr>
              <a:t>Figure S2H  </a:t>
            </a:r>
            <a:endParaRPr lang="de-DE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1AD79B89-14C9-44E4-4651-1D7C3D7ADC9A}"/>
              </a:ext>
            </a:extLst>
          </p:cNvPr>
          <p:cNvSpPr txBox="1"/>
          <p:nvPr/>
        </p:nvSpPr>
        <p:spPr>
          <a:xfrm>
            <a:off x="3991162" y="1992193"/>
            <a:ext cx="1663700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mBDNF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B2F338FB-2316-C729-AA36-B32F3EF14F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39459" y="1528610"/>
            <a:ext cx="4458269" cy="3748999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D676A9C6-1A83-FE66-D3FF-77E1AC635C4B}"/>
              </a:ext>
            </a:extLst>
          </p:cNvPr>
          <p:cNvSpPr txBox="1"/>
          <p:nvPr/>
        </p:nvSpPr>
        <p:spPr>
          <a:xfrm>
            <a:off x="630082" y="1303390"/>
            <a:ext cx="2508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 Psi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B3EE2D6-E11A-F265-F8B3-7EAFD43687C1}"/>
              </a:ext>
            </a:extLst>
          </p:cNvPr>
          <p:cNvSpPr txBox="1"/>
          <p:nvPr/>
        </p:nvSpPr>
        <p:spPr>
          <a:xfrm>
            <a:off x="332100" y="4494063"/>
            <a:ext cx="2508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 Psi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57125329-0212-5349-99CD-D0B956B98E83}"/>
              </a:ext>
            </a:extLst>
          </p:cNvPr>
          <p:cNvSpPr txBox="1"/>
          <p:nvPr/>
        </p:nvSpPr>
        <p:spPr>
          <a:xfrm>
            <a:off x="5796933" y="1251611"/>
            <a:ext cx="2508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 Psi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D74F5570-B847-E07B-C44B-B62256F6DC10}"/>
              </a:ext>
            </a:extLst>
          </p:cNvPr>
          <p:cNvSpPr txBox="1"/>
          <p:nvPr/>
        </p:nvSpPr>
        <p:spPr>
          <a:xfrm>
            <a:off x="9969323" y="927750"/>
            <a:ext cx="1663700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mBDNF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7039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B75708C-7E34-5442-9CB4-B6A20694A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593BD-2FAD-9843-96E5-C3CD8F1015F4}" type="slidenum">
              <a:rPr lang="de-DE" smtClean="0"/>
              <a:t>2</a:t>
            </a:fld>
            <a:endParaRPr lang="de-DE"/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DB945AD9-FE56-CB4C-B8D9-1A80FCE363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8924" t="701" r="1234" b="-1562"/>
          <a:stretch/>
        </p:blipFill>
        <p:spPr>
          <a:xfrm>
            <a:off x="1449573" y="1501632"/>
            <a:ext cx="1593159" cy="4854718"/>
          </a:xfrm>
          <a:prstGeom prst="rect">
            <a:avLst/>
          </a:prstGeom>
        </p:spPr>
      </p:pic>
      <p:pic>
        <p:nvPicPr>
          <p:cNvPr id="13" name="Inhaltsplatzhalter 5" descr="Ein Bild, das Schrank, Küche, Wasser, Raum enthält.&#10;&#10;Automatisch generierte Beschreibung">
            <a:extLst>
              <a:ext uri="{FF2B5EF4-FFF2-40B4-BE49-F238E27FC236}">
                <a16:creationId xmlns:a16="http://schemas.microsoft.com/office/drawing/2014/main" id="{2AB8614B-1D8F-5240-8EE7-10705FD89BA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/>
          <a:srcRect l="-1803" t="-3690" r="-1576" b="-995"/>
          <a:stretch/>
        </p:blipFill>
        <p:spPr>
          <a:xfrm>
            <a:off x="5743258" y="1954045"/>
            <a:ext cx="5610542" cy="4090344"/>
          </a:xfrm>
        </p:spPr>
      </p:pic>
      <p:sp>
        <p:nvSpPr>
          <p:cNvPr id="19" name="Titel 1">
            <a:extLst>
              <a:ext uri="{FF2B5EF4-FFF2-40B4-BE49-F238E27FC236}">
                <a16:creationId xmlns:a16="http://schemas.microsoft.com/office/drawing/2014/main" id="{8DCEB220-5095-161E-B6C3-D60E6CB868AF}"/>
              </a:ext>
            </a:extLst>
          </p:cNvPr>
          <p:cNvSpPr txBox="1">
            <a:spLocks/>
          </p:cNvSpPr>
          <p:nvPr/>
        </p:nvSpPr>
        <p:spPr>
          <a:xfrm>
            <a:off x="990600" y="5175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Figure S2H 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4CDA3C5D-66E4-AFDA-A6D6-FAC74CDD9DF2}"/>
              </a:ext>
            </a:extLst>
          </p:cNvPr>
          <p:cNvSpPr txBox="1"/>
          <p:nvPr/>
        </p:nvSpPr>
        <p:spPr>
          <a:xfrm>
            <a:off x="469051" y="2643045"/>
            <a:ext cx="225083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TrKB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(~ 100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45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BB0BB4C1-84DA-9E83-B1AF-E5DCA14611C8}"/>
              </a:ext>
            </a:extLst>
          </p:cNvPr>
          <p:cNvSpPr txBox="1"/>
          <p:nvPr/>
        </p:nvSpPr>
        <p:spPr>
          <a:xfrm>
            <a:off x="4018372" y="3460608"/>
            <a:ext cx="22508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45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pro-BDNF (34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3798D9CD-E170-2084-6BC6-7B5CFC09DDF4}"/>
              </a:ext>
            </a:extLst>
          </p:cNvPr>
          <p:cNvSpPr txBox="1"/>
          <p:nvPr/>
        </p:nvSpPr>
        <p:spPr>
          <a:xfrm>
            <a:off x="2137285" y="1954045"/>
            <a:ext cx="2508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     Psi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CC5786C6-7454-CBE4-2421-188AC24EA4BB}"/>
              </a:ext>
            </a:extLst>
          </p:cNvPr>
          <p:cNvSpPr txBox="1"/>
          <p:nvPr/>
        </p:nvSpPr>
        <p:spPr>
          <a:xfrm>
            <a:off x="6364555" y="4045383"/>
            <a:ext cx="2508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    Psi</a:t>
            </a:r>
          </a:p>
        </p:txBody>
      </p:sp>
    </p:spTree>
    <p:extLst>
      <p:ext uri="{BB962C8B-B14F-4D97-AF65-F5344CB8AC3E}">
        <p14:creationId xmlns:p14="http://schemas.microsoft.com/office/powerpoint/2010/main" val="1175514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Macintosh PowerPoint</Application>
  <PresentationFormat>Breitbild</PresentationFormat>
  <Paragraphs>42</Paragraphs>
  <Slides>2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Figure S2H  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u: WB: BDNF (elab), Gel 1 25 µg protein Influence of recombinant proBDNF </dc:title>
  <dc:creator>Microsoft Office User</dc:creator>
  <cp:lastModifiedBy>Microsoft Office User</cp:lastModifiedBy>
  <cp:revision>13</cp:revision>
  <dcterms:created xsi:type="dcterms:W3CDTF">2026-02-25T12:34:02Z</dcterms:created>
  <dcterms:modified xsi:type="dcterms:W3CDTF">2026-03-03T10:28:32Z</dcterms:modified>
</cp:coreProperties>
</file>